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34C06D-A338-4414-85DD-467260FBEB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ED96D-70E5-4B63-82EB-7D73E0BD81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EF67E7-1CD6-4EA4-92B0-2FD3C437FD1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513695-373A-4870-BD24-9976B07E90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0E4302-BB47-4B6C-A05B-16B0A4AC0A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EE09C0-8627-404F-ADD6-13388513E3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1D4E7-B739-4BAA-ABB0-7B4B614229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186F5B-B23F-4DE3-8D44-6CB976D243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2CFBDB-08E5-42DD-B915-B4816B2F64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90FA08-6945-4133-8831-3510035216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85913-331C-49EB-BD09-6955B569A5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02A008-56EB-43B0-90DA-D7D30CDA82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E3C296-36CB-454F-B24F-1F75EAB5619B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 16"/>
          <p:cNvGrpSpPr/>
          <p:nvPr/>
        </p:nvGrpSpPr>
        <p:grpSpPr>
          <a:xfrm>
            <a:off x="642960" y="428760"/>
            <a:ext cx="6386400" cy="6004440"/>
            <a:chOff x="642960" y="428760"/>
            <a:chExt cx="6386400" cy="6004440"/>
          </a:xfrm>
        </p:grpSpPr>
        <p:pic>
          <p:nvPicPr>
            <p:cNvPr id="42" name="Image 3" descr=""/>
            <p:cNvPicPr/>
            <p:nvPr/>
          </p:nvPicPr>
          <p:blipFill>
            <a:blip r:embed="rId1"/>
            <a:stretch/>
          </p:blipFill>
          <p:spPr>
            <a:xfrm>
              <a:off x="2268720" y="428760"/>
              <a:ext cx="3019680" cy="1551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ZoneTexte 4"/>
            <p:cNvSpPr/>
            <p:nvPr/>
          </p:nvSpPr>
          <p:spPr>
            <a:xfrm>
              <a:off x="3276720" y="1869120"/>
              <a:ext cx="1003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icosulfur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ZoneTexte 7"/>
            <p:cNvSpPr/>
            <p:nvPr/>
          </p:nvSpPr>
          <p:spPr>
            <a:xfrm>
              <a:off x="1167840" y="3701160"/>
              <a:ext cx="760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D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" name="Image 5" descr=""/>
            <p:cNvPicPr/>
            <p:nvPr/>
          </p:nvPicPr>
          <p:blipFill>
            <a:blip r:embed="rId2"/>
            <a:stretch/>
          </p:blipFill>
          <p:spPr>
            <a:xfrm>
              <a:off x="642960" y="2596320"/>
              <a:ext cx="1464120" cy="99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Image 10" descr=""/>
            <p:cNvPicPr/>
            <p:nvPr/>
          </p:nvPicPr>
          <p:blipFill>
            <a:blip r:embed="rId3"/>
            <a:stretch/>
          </p:blipFill>
          <p:spPr>
            <a:xfrm>
              <a:off x="5565240" y="2566800"/>
              <a:ext cx="1464120" cy="1048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ZoneTexte 13"/>
            <p:cNvSpPr/>
            <p:nvPr/>
          </p:nvSpPr>
          <p:spPr>
            <a:xfrm>
              <a:off x="5913360" y="3701160"/>
              <a:ext cx="63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DM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ZoneTexte 16"/>
            <p:cNvSpPr/>
            <p:nvPr/>
          </p:nvSpPr>
          <p:spPr>
            <a:xfrm>
              <a:off x="3579840" y="4067640"/>
              <a:ext cx="36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9" name="Image 1" descr=""/>
            <p:cNvPicPr/>
            <p:nvPr/>
          </p:nvPicPr>
          <p:blipFill>
            <a:blip r:embed="rId4"/>
            <a:stretch/>
          </p:blipFill>
          <p:spPr>
            <a:xfrm>
              <a:off x="2333160" y="2517480"/>
              <a:ext cx="2955240" cy="162576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50" name="Connecteur droit avec flèche 78"/>
            <p:cNvCxnSpPr/>
            <p:nvPr/>
          </p:nvCxnSpPr>
          <p:spPr>
            <a:xfrm flipH="1">
              <a:off x="1881000" y="2000160"/>
              <a:ext cx="451080" cy="451800"/>
            </a:xfrm>
            <a:prstGeom prst="straightConnector1">
              <a:avLst/>
            </a:prstGeom>
            <a:ln w="57240">
              <a:solidFill>
                <a:srgbClr val="000000"/>
              </a:solidFill>
              <a:miter/>
              <a:tailEnd len="sm" type="triangle" w="sm"/>
            </a:ln>
          </p:spPr>
        </p:cxnSp>
        <p:cxnSp>
          <p:nvCxnSpPr>
            <p:cNvPr id="51" name="Connecteur droit avec flèche 82"/>
            <p:cNvCxnSpPr/>
            <p:nvPr/>
          </p:nvCxnSpPr>
          <p:spPr>
            <a:xfrm>
              <a:off x="3777840" y="2112840"/>
              <a:ext cx="1080" cy="40536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2" name="Connecteur droit avec flèche 83"/>
            <p:cNvCxnSpPr/>
            <p:nvPr/>
          </p:nvCxnSpPr>
          <p:spPr>
            <a:xfrm>
              <a:off x="5085000" y="1981800"/>
              <a:ext cx="451080" cy="450000"/>
            </a:xfrm>
            <a:prstGeom prst="straightConnector1">
              <a:avLst/>
            </a:prstGeom>
            <a:ln w="57240">
              <a:solidFill>
                <a:srgbClr val="000000"/>
              </a:solidFill>
              <a:miter/>
              <a:tailEnd len="sm" type="triangle" w="sm"/>
            </a:ln>
          </p:spPr>
        </p:cxnSp>
        <p:pic>
          <p:nvPicPr>
            <p:cNvPr id="53" name="Image 2" descr=""/>
            <p:cNvPicPr/>
            <p:nvPr/>
          </p:nvPicPr>
          <p:blipFill>
            <a:blip r:embed="rId5"/>
            <a:stretch/>
          </p:blipFill>
          <p:spPr>
            <a:xfrm>
              <a:off x="2316240" y="4674240"/>
              <a:ext cx="2994480" cy="164664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54" name="Connecteur droit avec flèche 14"/>
            <p:cNvCxnSpPr/>
            <p:nvPr/>
          </p:nvCxnSpPr>
          <p:spPr>
            <a:xfrm>
              <a:off x="3777840" y="4337280"/>
              <a:ext cx="1080" cy="4053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sm" type="triangle" w="sm"/>
            </a:ln>
          </p:spPr>
        </p:cxnSp>
        <p:sp>
          <p:nvSpPr>
            <p:cNvPr id="55" name="ZoneTexte 15"/>
            <p:cNvSpPr/>
            <p:nvPr/>
          </p:nvSpPr>
          <p:spPr>
            <a:xfrm>
              <a:off x="3576960" y="6156720"/>
              <a:ext cx="36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Accolade fermante 15"/>
          <p:cNvSpPr/>
          <p:nvPr/>
        </p:nvSpPr>
        <p:spPr>
          <a:xfrm>
            <a:off x="7500960" y="2343240"/>
            <a:ext cx="142920" cy="1800000"/>
          </a:xfrm>
          <a:custGeom>
            <a:avLst/>
            <a:gdLst>
              <a:gd name="textAreaLeft" fmla="*/ 0 w 142920"/>
              <a:gd name="textAreaRight" fmla="*/ 51480 w 142920"/>
              <a:gd name="textAreaTop" fmla="*/ 3600 h 1800000"/>
              <a:gd name="textAreaBottom" fmla="*/ 1796400 h 1800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72"/>
                  <a:pt x="10800" y="143"/>
                </a:cubicBezTo>
                <a:lnTo>
                  <a:pt x="10800" y="10657"/>
                </a:lnTo>
                <a:cubicBezTo>
                  <a:pt x="10800" y="10729"/>
                  <a:pt x="16200" y="10800"/>
                  <a:pt x="21600" y="10800"/>
                </a:cubicBezTo>
                <a:cubicBezTo>
                  <a:pt x="16200" y="10800"/>
                  <a:pt x="10800" y="10872"/>
                  <a:pt x="10800" y="10943"/>
                </a:cubicBezTo>
                <a:lnTo>
                  <a:pt x="10800" y="21457"/>
                </a:lnTo>
                <a:cubicBezTo>
                  <a:pt x="10800" y="21529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Accolade fermante 17"/>
          <p:cNvSpPr/>
          <p:nvPr/>
        </p:nvSpPr>
        <p:spPr>
          <a:xfrm>
            <a:off x="7215120" y="2541600"/>
            <a:ext cx="142920" cy="3959280"/>
          </a:xfrm>
          <a:custGeom>
            <a:avLst/>
            <a:gdLst>
              <a:gd name="textAreaLeft" fmla="*/ 0 w 142920"/>
              <a:gd name="textAreaRight" fmla="*/ 51480 w 142920"/>
              <a:gd name="textAreaTop" fmla="*/ 3600 h 3959280"/>
              <a:gd name="textAreaBottom" fmla="*/ 3955680 h 3959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3"/>
                  <a:pt x="10800" y="65"/>
                </a:cubicBezTo>
                <a:lnTo>
                  <a:pt x="10800" y="10735"/>
                </a:lnTo>
                <a:cubicBezTo>
                  <a:pt x="10800" y="10768"/>
                  <a:pt x="16200" y="10800"/>
                  <a:pt x="21600" y="10800"/>
                </a:cubicBezTo>
                <a:cubicBezTo>
                  <a:pt x="16200" y="10800"/>
                  <a:pt x="10800" y="10833"/>
                  <a:pt x="10800" y="10865"/>
                </a:cubicBezTo>
                <a:lnTo>
                  <a:pt x="10800" y="21535"/>
                </a:lnTo>
                <a:cubicBezTo>
                  <a:pt x="10800" y="21568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ZoneTexte 18"/>
          <p:cNvSpPr/>
          <p:nvPr/>
        </p:nvSpPr>
        <p:spPr>
          <a:xfrm>
            <a:off x="7596360" y="3038400"/>
            <a:ext cx="1428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lanktonic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cucumerina 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ZoneTexte 19"/>
          <p:cNvSpPr/>
          <p:nvPr/>
        </p:nvSpPr>
        <p:spPr>
          <a:xfrm>
            <a:off x="7308720" y="4286160"/>
            <a:ext cx="1428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enthic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cucumerina 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3"/>
          <p:cNvSpPr/>
          <p:nvPr/>
        </p:nvSpPr>
        <p:spPr>
          <a:xfrm>
            <a:off x="244440" y="154440"/>
            <a:ext cx="177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Figure S1 :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arles et al.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Rectangle 3"/>
          <p:cNvSpPr/>
          <p:nvPr/>
        </p:nvSpPr>
        <p:spPr>
          <a:xfrm>
            <a:off x="428760" y="357120"/>
            <a:ext cx="82152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Proposed scheme of nicosulfuron biodegradation pathway by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cucumerina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 planktonic and benthic conditions (adapted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rom Carles et al., 2017a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thick and thin arrows show the main and the minor pathways, respectively.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DM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2-(aminosulfonyl)-N,N-dimethyl-3-pyridinecarboxamide;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MP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2-amino-4,6-dimethoxypyrimidine,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2-(1-(4,6-dimethoxy-pyrimidin-2-yl)-ureido)-N,N-dimethyl-nicotinamide,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4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2-(4,6-dimethoxy-pyrimidin-2-yl)-N,N-dimethyl-nicotinamid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5-23T13:42:55Z</dcterms:created>
  <dc:creator>Isabelle</dc:creator>
  <dc:description/>
  <dc:language>en-US</dc:language>
  <cp:lastModifiedBy>Isabelle</cp:lastModifiedBy>
  <dcterms:modified xsi:type="dcterms:W3CDTF">2018-11-30T13:38:36Z</dcterms:modified>
  <cp:revision>16</cp:revision>
  <dc:subject/>
  <dc:title>Diapositive 1</dc:title>
</cp:coreProperties>
</file>